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EE6520-55B0-4B37-8F8E-D1BC47785A6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1190AF-410B-42CB-9C7F-80B4F6D4A71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79E951-F0C7-4EB0-A729-69A71ED78B1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403233-4A2B-486D-BD06-0B77C4A02A1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3262E2-693F-4CA7-BE18-9F2D1087587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FE90E1-A46A-4D71-83D2-6210D4CD18F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BCE22D-9F3D-4481-B22B-8F8F1DA27E8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A35699-432E-4960-BE36-B0A7472E5D2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BAFA3B-3A61-4F0A-8E6F-2918E7A8D3A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A0774E-9EE3-4F7A-848C-B725E050F74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3F8F42-8B6C-4570-AE03-1ECF5E2B1ED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F195DE-9CE7-4F37-B355-DB4640EDCDE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AE48CB9-AF0F-4100-8CA7-F34F34E90473}" type="slidenum">
              <a:rPr b="0" lang="en-GB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1"/>
          <p:cNvSpPr/>
          <p:nvPr/>
        </p:nvSpPr>
        <p:spPr>
          <a:xfrm>
            <a:off x="108000" y="5950080"/>
            <a:ext cx="89280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Supplementary Figure 4. Annotation for the reading and spelling association in the region surrounding rs4807927. Linkage disequilibrium is represented by r2. Non-synonymous (▼) and coding (■) SNPs can be observed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Picture 9" descr=""/>
          <p:cNvPicPr/>
          <p:nvPr/>
        </p:nvPicPr>
        <p:blipFill>
          <a:blip r:embed="rId1"/>
          <a:stretch/>
        </p:blipFill>
        <p:spPr>
          <a:xfrm>
            <a:off x="271440" y="433440"/>
            <a:ext cx="8601120" cy="5300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185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4-01T15:30:57Z</dcterms:created>
  <dc:creator>mluciano</dc:creator>
  <dc:description/>
  <dc:language>en-US</dc:language>
  <cp:lastModifiedBy>LUCIANO Michelle</cp:lastModifiedBy>
  <dcterms:modified xsi:type="dcterms:W3CDTF">2013-04-19T08:41:24Z</dcterms:modified>
  <cp:revision>13</cp:revision>
  <dc:subject/>
  <dc:title>Slide 1</dc:title>
</cp:coreProperties>
</file>